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FB5A42-37E0-4643-AEDC-75541B5237C6}" v="1" dt="2023-05-24T02:41:10.9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3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ung-Tae Lee" userId="33e46823-6cac-49d4-a2f1-aeb850dcc283" providerId="ADAL" clId="{BFFB5A42-37E0-4643-AEDC-75541B5237C6}"/>
    <pc:docChg chg="undo redo custSel modSld">
      <pc:chgData name="Young-Tae Lee" userId="33e46823-6cac-49d4-a2f1-aeb850dcc283" providerId="ADAL" clId="{BFFB5A42-37E0-4643-AEDC-75541B5237C6}" dt="2023-05-24T02:37:51.774" v="52" actId="1076"/>
      <pc:docMkLst>
        <pc:docMk/>
      </pc:docMkLst>
      <pc:sldChg chg="addSp delSp modSp mod">
        <pc:chgData name="Young-Tae Lee" userId="33e46823-6cac-49d4-a2f1-aeb850dcc283" providerId="ADAL" clId="{BFFB5A42-37E0-4643-AEDC-75541B5237C6}" dt="2023-05-24T02:37:51.774" v="52" actId="1076"/>
        <pc:sldMkLst>
          <pc:docMk/>
          <pc:sldMk cId="1566146016" sldId="256"/>
        </pc:sldMkLst>
        <pc:spChg chg="add del">
          <ac:chgData name="Young-Tae Lee" userId="33e46823-6cac-49d4-a2f1-aeb850dcc283" providerId="ADAL" clId="{BFFB5A42-37E0-4643-AEDC-75541B5237C6}" dt="2023-05-24T02:34:00.476" v="4" actId="478"/>
          <ac:spMkLst>
            <pc:docMk/>
            <pc:sldMk cId="1566146016" sldId="256"/>
            <ac:spMk id="6" creationId="{BA127FE8-0014-0CD4-E0F7-B3C9CE4EDAC2}"/>
          </ac:spMkLst>
        </pc:spChg>
        <pc:spChg chg="mod">
          <ac:chgData name="Young-Tae Lee" userId="33e46823-6cac-49d4-a2f1-aeb850dcc283" providerId="ADAL" clId="{BFFB5A42-37E0-4643-AEDC-75541B5237C6}" dt="2023-05-24T02:37:51.774" v="52" actId="1076"/>
          <ac:spMkLst>
            <pc:docMk/>
            <pc:sldMk cId="1566146016" sldId="256"/>
            <ac:spMk id="11" creationId="{E8A77F3C-B8B9-C6D9-5FF9-04B39AF589B7}"/>
          </ac:spMkLst>
        </pc:spChg>
        <pc:picChg chg="mod">
          <ac:chgData name="Young-Tae Lee" userId="33e46823-6cac-49d4-a2f1-aeb850dcc283" providerId="ADAL" clId="{BFFB5A42-37E0-4643-AEDC-75541B5237C6}" dt="2023-05-24T02:37:29.716" v="40" actId="14100"/>
          <ac:picMkLst>
            <pc:docMk/>
            <pc:sldMk cId="1566146016" sldId="256"/>
            <ac:picMk id="4" creationId="{80DDB3DC-D7B9-5C2B-BEAB-6AC428692863}"/>
          </ac:picMkLst>
        </pc:picChg>
        <pc:picChg chg="mod">
          <ac:chgData name="Young-Tae Lee" userId="33e46823-6cac-49d4-a2f1-aeb850dcc283" providerId="ADAL" clId="{BFFB5A42-37E0-4643-AEDC-75541B5237C6}" dt="2023-05-24T02:37:47.965" v="51" actId="1038"/>
          <ac:picMkLst>
            <pc:docMk/>
            <pc:sldMk cId="1566146016" sldId="256"/>
            <ac:picMk id="5" creationId="{B03CDAC9-0062-3CCC-75D7-AAB19DAB2851}"/>
          </ac:picMkLst>
        </pc:picChg>
      </pc:sldChg>
      <pc:sldChg chg="delSp modSp mod">
        <pc:chgData name="Young-Tae Lee" userId="33e46823-6cac-49d4-a2f1-aeb850dcc283" providerId="ADAL" clId="{BFFB5A42-37E0-4643-AEDC-75541B5237C6}" dt="2023-05-24T02:36:30.378" v="34" actId="1076"/>
        <pc:sldMkLst>
          <pc:docMk/>
          <pc:sldMk cId="3600529432" sldId="257"/>
        </pc:sldMkLst>
        <pc:spChg chg="del">
          <ac:chgData name="Young-Tae Lee" userId="33e46823-6cac-49d4-a2f1-aeb850dcc283" providerId="ADAL" clId="{BFFB5A42-37E0-4643-AEDC-75541B5237C6}" dt="2023-05-24T02:34:04.028" v="5" actId="478"/>
          <ac:spMkLst>
            <pc:docMk/>
            <pc:sldMk cId="3600529432" sldId="257"/>
            <ac:spMk id="3" creationId="{066A6DD1-D46D-C230-A8F9-0E2A25CB90F8}"/>
          </ac:spMkLst>
        </pc:spChg>
        <pc:spChg chg="mod">
          <ac:chgData name="Young-Tae Lee" userId="33e46823-6cac-49d4-a2f1-aeb850dcc283" providerId="ADAL" clId="{BFFB5A42-37E0-4643-AEDC-75541B5237C6}" dt="2023-05-24T02:35:47.873" v="24" actId="1076"/>
          <ac:spMkLst>
            <pc:docMk/>
            <pc:sldMk cId="3600529432" sldId="257"/>
            <ac:spMk id="4" creationId="{EB8EB3B0-1583-E4AF-CD24-9D82AEEC1BF1}"/>
          </ac:spMkLst>
        </pc:spChg>
        <pc:spChg chg="mod">
          <ac:chgData name="Young-Tae Lee" userId="33e46823-6cac-49d4-a2f1-aeb850dcc283" providerId="ADAL" clId="{BFFB5A42-37E0-4643-AEDC-75541B5237C6}" dt="2023-05-24T02:34:59.962" v="17" actId="1076"/>
          <ac:spMkLst>
            <pc:docMk/>
            <pc:sldMk cId="3600529432" sldId="257"/>
            <ac:spMk id="5" creationId="{1BDC205A-259A-E156-40EB-AF30A28606EB}"/>
          </ac:spMkLst>
        </pc:spChg>
        <pc:spChg chg="mod">
          <ac:chgData name="Young-Tae Lee" userId="33e46823-6cac-49d4-a2f1-aeb850dcc283" providerId="ADAL" clId="{BFFB5A42-37E0-4643-AEDC-75541B5237C6}" dt="2023-05-24T02:35:20.001" v="21" actId="1076"/>
          <ac:spMkLst>
            <pc:docMk/>
            <pc:sldMk cId="3600529432" sldId="257"/>
            <ac:spMk id="6" creationId="{AD0C478F-F4A4-5A20-0A66-DF08E39BE9DF}"/>
          </ac:spMkLst>
        </pc:spChg>
        <pc:spChg chg="mod">
          <ac:chgData name="Young-Tae Lee" userId="33e46823-6cac-49d4-a2f1-aeb850dcc283" providerId="ADAL" clId="{BFFB5A42-37E0-4643-AEDC-75541B5237C6}" dt="2023-05-24T02:35:09.072" v="20" actId="1076"/>
          <ac:spMkLst>
            <pc:docMk/>
            <pc:sldMk cId="3600529432" sldId="257"/>
            <ac:spMk id="7" creationId="{AFDAE832-B11E-7237-F5C4-464B29C149B4}"/>
          </ac:spMkLst>
        </pc:spChg>
        <pc:spChg chg="mod">
          <ac:chgData name="Young-Tae Lee" userId="33e46823-6cac-49d4-a2f1-aeb850dcc283" providerId="ADAL" clId="{BFFB5A42-37E0-4643-AEDC-75541B5237C6}" dt="2023-05-24T02:36:30.378" v="34" actId="1076"/>
          <ac:spMkLst>
            <pc:docMk/>
            <pc:sldMk cId="3600529432" sldId="257"/>
            <ac:spMk id="8" creationId="{650A02A0-88CF-DEC4-0670-554EDEBFFC1A}"/>
          </ac:spMkLst>
        </pc:spChg>
        <pc:picChg chg="mod">
          <ac:chgData name="Young-Tae Lee" userId="33e46823-6cac-49d4-a2f1-aeb850dcc283" providerId="ADAL" clId="{BFFB5A42-37E0-4643-AEDC-75541B5237C6}" dt="2023-05-24T02:34:54.995" v="16" actId="1076"/>
          <ac:picMkLst>
            <pc:docMk/>
            <pc:sldMk cId="3600529432" sldId="257"/>
            <ac:picMk id="2" creationId="{21FE68AE-F32F-F861-AB13-08CE1E21FC4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249942-0736-17AE-B4C4-3FF9EB9711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77CE4D-71B2-9AC9-F124-95F1079657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E8046A-413D-436D-4FE4-C383B3C68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8365CE-9A41-1F80-7A2A-BA17963F4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87B938-EE89-A520-6184-966F7CCF3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172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6B459A-1A89-8F19-032D-13D4767DA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CF534C-558D-391A-B463-D12D3E3AF5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96782-2B97-548E-DFB3-EC195A826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4A80E6-DA65-81A4-28D8-758C42974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C99D9C-A91D-A035-D9AC-1F2CF683D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54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C6D316-B272-48F4-321C-4B0724BA14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7D8D2B-79AC-5478-D32B-DD2B9454D7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86C51D-1A34-FBC0-F406-D949C7E21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B226D-07C6-C132-DA34-6AF801526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436B5-EF45-3961-2E62-9C09407D3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38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7B565-109F-E9BE-8AB6-64B3766644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1E79EB-2859-ABF0-E03C-353F4156CE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71324A-04E1-7C25-C58D-C0234C5BC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19A93C-D9F4-EBA2-EC81-E189B3808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004BA7-2C29-FF2A-CB83-FBA64E6F8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62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9C1BD-9B01-FA50-B3C6-3EA89090B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47C367-C20E-859F-4E6E-26F9553FB2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902821-1828-8420-2166-8E3FD4BE0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88356-2768-646F-3E58-55D8DB759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DB31BC-39B9-C7C6-F89E-133D382D8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408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E71A06-A383-69FE-9322-06BA664E4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284C9F-9919-0636-C858-40914AF25D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003060-7182-C52F-DBF9-C8A22DCEDD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6B0DD7-1CCD-D593-A436-517185013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F5A02E-98E9-843C-99C8-FD281602E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BC502E-35C9-69ED-9E5F-9CCAB85B7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641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5CFA9-6096-C8BB-0D19-8CF8B30E0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D38591-57C8-8D42-D969-64DED18A8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8EDAFD-ABDF-5EFA-1C39-5D58838235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AC8F15-420F-0DD6-1B17-C95711DCD9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4E6A1C-6038-A636-F0BE-267CC8E8E0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3300B3-F00A-BBF9-7D97-0252BDC5F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55B325-D787-D571-D82E-E97AB51D2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A7DA9E-777E-8A8F-F39B-BC0AE13BD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280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B4C66-C7BA-C9B7-9478-D21268760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F1A48E-5FBD-2064-A2D8-4D4E7E208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F77C94-AFD8-EE3E-5D15-EB996D809E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C0BD36-7332-F558-851D-1463C3D7F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444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CEA29D-5E57-55F6-F3D0-278DEB304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F1DDD4D-7749-AF28-696F-642777319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D97A9A-E236-568F-D41A-13BC2F316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660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69C49-5BC8-22C9-8AD1-2DAC5F6ED0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A28A98-E111-AEC0-C978-92C4A44EA1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87A0E1-A994-065B-88CB-905650A125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42C097-1F2E-E415-FF47-3C26B4F1C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ABB7FA-CF6A-8935-7664-E4ECE6E7D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CE50D0-C50B-CC83-4B93-D7C75DC69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95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7653BA-BA54-58CC-581E-66EEE0571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D2E82D-A9F2-6015-C713-911927FFD1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B51C8E-5952-1D96-E842-3426223D5E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5ECB9C-D703-53E4-7962-7810D479C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DD54D1-9B4B-BEAF-C05A-3208C1F8B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1586E9-7B58-CDC4-E3DF-BED10EB7F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573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E334F9-B6BD-4CF1-BE9C-D83243C71B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B8EB43-D132-517C-0DE7-75A644B008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1250-A574-27FD-F117-B0DFE3F242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09865-C695-4763-8D02-050D7CAFDD3A}" type="datetimeFigureOut">
              <a:rPr lang="en-US" smtClean="0"/>
              <a:t>5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B7D40A-5D4B-EF98-32B7-817C06F9DC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F2519-12FF-BC11-3A49-99B06E6E50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1469C-27C2-4A17-B21B-E44EC0729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258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">
            <a:hlinkClick r:id="" action="ppaction://media"/>
            <a:extLst>
              <a:ext uri="{FF2B5EF4-FFF2-40B4-BE49-F238E27FC236}">
                <a16:creationId xmlns:a16="http://schemas.microsoft.com/office/drawing/2014/main" id="{80DDB3DC-D7B9-5C2B-BEAB-6AC42869286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828110" y="932949"/>
            <a:ext cx="3327691" cy="3472372"/>
          </a:xfrm>
          <a:prstGeom prst="rect">
            <a:avLst/>
          </a:prstGeom>
        </p:spPr>
      </p:pic>
      <p:pic>
        <p:nvPicPr>
          <p:cNvPr id="5" name="2">
            <a:hlinkClick r:id="" action="ppaction://media"/>
            <a:extLst>
              <a:ext uri="{FF2B5EF4-FFF2-40B4-BE49-F238E27FC236}">
                <a16:creationId xmlns:a16="http://schemas.microsoft.com/office/drawing/2014/main" id="{B03CDAC9-0062-3CCC-75D7-AAB19DAB2851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911621" y="932700"/>
            <a:ext cx="2531939" cy="3472372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697ADAA-AF48-DFC1-8E40-B603BFB51085}"/>
              </a:ext>
            </a:extLst>
          </p:cNvPr>
          <p:cNvCxnSpPr>
            <a:cxnSpLocks/>
          </p:cNvCxnSpPr>
          <p:nvPr/>
        </p:nvCxnSpPr>
        <p:spPr>
          <a:xfrm>
            <a:off x="5951742" y="2244435"/>
            <a:ext cx="0" cy="242453"/>
          </a:xfrm>
          <a:prstGeom prst="line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or: Curved 7">
            <a:extLst>
              <a:ext uri="{FF2B5EF4-FFF2-40B4-BE49-F238E27FC236}">
                <a16:creationId xmlns:a16="http://schemas.microsoft.com/office/drawing/2014/main" id="{291ABAC4-B22B-3716-F2CC-7E30EB283F4E}"/>
              </a:ext>
            </a:extLst>
          </p:cNvPr>
          <p:cNvCxnSpPr>
            <a:cxnSpLocks/>
          </p:cNvCxnSpPr>
          <p:nvPr/>
        </p:nvCxnSpPr>
        <p:spPr>
          <a:xfrm rot="10800000" flipH="1">
            <a:off x="5897214" y="2355045"/>
            <a:ext cx="109057" cy="12700"/>
          </a:xfrm>
          <a:prstGeom prst="curvedConnector5">
            <a:avLst>
              <a:gd name="adj1" fmla="val -129762"/>
              <a:gd name="adj2" fmla="val -1255646"/>
              <a:gd name="adj3" fmla="val 259706"/>
            </a:avLst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3FD8012-0740-EAF3-5868-5AFD176443B4}"/>
              </a:ext>
            </a:extLst>
          </p:cNvPr>
          <p:cNvCxnSpPr>
            <a:cxnSpLocks/>
          </p:cNvCxnSpPr>
          <p:nvPr/>
        </p:nvCxnSpPr>
        <p:spPr>
          <a:xfrm>
            <a:off x="5951742" y="2567786"/>
            <a:ext cx="0" cy="127932"/>
          </a:xfrm>
          <a:prstGeom prst="line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9028634-7113-F016-74C9-9310BDE9C824}"/>
              </a:ext>
            </a:extLst>
          </p:cNvPr>
          <p:cNvSpPr txBox="1"/>
          <p:nvPr/>
        </p:nvSpPr>
        <p:spPr>
          <a:xfrm>
            <a:off x="5776812" y="264743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90˚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8A77F3C-B8B9-C6D9-5FF9-04B39AF589B7}"/>
              </a:ext>
            </a:extLst>
          </p:cNvPr>
          <p:cNvSpPr txBox="1"/>
          <p:nvPr/>
        </p:nvSpPr>
        <p:spPr>
          <a:xfrm>
            <a:off x="2722915" y="5093451"/>
            <a:ext cx="645765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deo S1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 animation of observed DHX9-ADP and MLE-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F</a:t>
            </a:r>
            <a:r>
              <a:rPr lang="en-US" sz="11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RN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formations. Human DHX9 chain A is morphed into MLE (PDB 5AOR), showing domain rearrangements between the two structures.  Color scheme as in Fig. 1; dsRBD is not shown. </a:t>
            </a:r>
          </a:p>
        </p:txBody>
      </p:sp>
    </p:spTree>
    <p:extLst>
      <p:ext uri="{BB962C8B-B14F-4D97-AF65-F5344CB8AC3E}">
        <p14:creationId xmlns:p14="http://schemas.microsoft.com/office/powerpoint/2010/main" val="156614601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4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0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5">
            <a:hlinkClick r:id="" action="ppaction://media"/>
            <a:extLst>
              <a:ext uri="{FF2B5EF4-FFF2-40B4-BE49-F238E27FC236}">
                <a16:creationId xmlns:a16="http://schemas.microsoft.com/office/drawing/2014/main" id="{21FE68AE-F32F-F861-AB13-08CE1E21FC4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025109" y="990494"/>
            <a:ext cx="3225998" cy="32259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B8EB3B0-1583-E4AF-CD24-9D82AEEC1BF1}"/>
              </a:ext>
            </a:extLst>
          </p:cNvPr>
          <p:cNvSpPr txBox="1"/>
          <p:nvPr/>
        </p:nvSpPr>
        <p:spPr>
          <a:xfrm>
            <a:off x="6298855" y="2334315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tif V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DC205A-259A-E156-40EB-AF30A28606EB}"/>
              </a:ext>
            </a:extLst>
          </p:cNvPr>
          <p:cNvSpPr txBox="1"/>
          <p:nvPr/>
        </p:nvSpPr>
        <p:spPr>
          <a:xfrm>
            <a:off x="5828939" y="3893580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tif IV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0C478F-F4A4-5A20-0A66-DF08E39BE9DF}"/>
              </a:ext>
            </a:extLst>
          </p:cNvPr>
          <p:cNvSpPr txBox="1"/>
          <p:nvPr/>
        </p:nvSpPr>
        <p:spPr>
          <a:xfrm>
            <a:off x="6046306" y="1672914"/>
            <a:ext cx="6335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ok loo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FDAE832-B11E-7237-F5C4-464B29C149B4}"/>
              </a:ext>
            </a:extLst>
          </p:cNvPr>
          <p:cNvSpPr txBox="1"/>
          <p:nvPr/>
        </p:nvSpPr>
        <p:spPr>
          <a:xfrm>
            <a:off x="4660132" y="1968464"/>
            <a:ext cx="3016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l-GR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8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0A02A0-88CF-DEC4-0670-554EDEBFFC1A}"/>
              </a:ext>
            </a:extLst>
          </p:cNvPr>
          <p:cNvSpPr txBox="1"/>
          <p:nvPr/>
        </p:nvSpPr>
        <p:spPr>
          <a:xfrm>
            <a:off x="2867172" y="4662449"/>
            <a:ext cx="645765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deo S2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Morph animation of the RecA2 nucleotide binding site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DHX9 chain A is morphed into MLE (PDB 5AOR)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ing RecA2 domain rotation and localized conformational changes of motif V at the nucleotide binding site relative to RecA1 (not shown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 scheme as in Fig. 1.</a:t>
            </a:r>
          </a:p>
        </p:txBody>
      </p:sp>
    </p:spTree>
    <p:extLst>
      <p:ext uri="{BB962C8B-B14F-4D97-AF65-F5344CB8AC3E}">
        <p14:creationId xmlns:p14="http://schemas.microsoft.com/office/powerpoint/2010/main" val="36005294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04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10</Words>
  <Application>Microsoft Office PowerPoint</Application>
  <PresentationFormat>Widescreen</PresentationFormat>
  <Paragraphs>7</Paragraphs>
  <Slides>2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Boriack-Sjodin</dc:creator>
  <cp:lastModifiedBy>Young-Tae Lee</cp:lastModifiedBy>
  <cp:revision>2</cp:revision>
  <dcterms:created xsi:type="dcterms:W3CDTF">2023-05-12T21:38:41Z</dcterms:created>
  <dcterms:modified xsi:type="dcterms:W3CDTF">2023-05-24T02:41:21Z</dcterms:modified>
</cp:coreProperties>
</file>